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68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Emilie_MAI2020\Peak_27_analyse_total_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Emilie_MAI2020\Peak_27_analyse_total_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cap="none" spc="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j-ea"/>
                <a:cs typeface="+mj-cs"/>
              </a:defRPr>
            </a:pPr>
            <a:r>
              <a:rPr lang="en-US" dirty="0" err="1"/>
              <a:t>ydcD</a:t>
            </a:r>
            <a:r>
              <a:rPr lang="en-US" baseline="0" dirty="0" err="1"/>
              <a:t>_duplicate</a:t>
            </a:r>
            <a:r>
              <a:rPr lang="en-US" baseline="0" dirty="0"/>
              <a:t> 1</a:t>
            </a:r>
          </a:p>
        </c:rich>
      </c:tx>
      <c:layout>
        <c:manualLayout>
          <c:xMode val="edge"/>
          <c:yMode val="edge"/>
          <c:x val="0.25904732856266227"/>
          <c:y val="2.66666666666666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cap="none" spc="50" normalizeH="0" baseline="0">
              <a:solidFill>
                <a:schemeClr val="tx1">
                  <a:lumMod val="65000"/>
                  <a:lumOff val="35000"/>
                </a:schemeClr>
              </a:solidFill>
              <a:latin typeface="+mj-lt"/>
              <a:ea typeface="+mj-ea"/>
              <a:cs typeface="+mj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A$13</c:f>
              <c:strCache>
                <c:ptCount val="1"/>
                <c:pt idx="0">
                  <c:v>sDRIP</c:v>
                </c:pt>
              </c:strCache>
            </c:strRef>
          </c:tx>
          <c:spPr>
            <a:solidFill>
              <a:schemeClr val="accent1">
                <a:alpha val="70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713-4C19-8928-B672F00C3D2C}"/>
              </c:ext>
            </c:extLst>
          </c:dPt>
          <c:dPt>
            <c:idx val="3"/>
            <c:invertIfNegative val="0"/>
            <c:bubble3D val="0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713-4C19-8928-B672F00C3D2C}"/>
              </c:ext>
            </c:extLst>
          </c:dPt>
          <c:dPt>
            <c:idx val="5"/>
            <c:invertIfNegative val="0"/>
            <c:bubble3D val="0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713-4C19-8928-B672F00C3D2C}"/>
              </c:ext>
            </c:extLst>
          </c:dPt>
          <c:cat>
            <c:strRef>
              <c:f>Feuil1!$B$12:$G$12</c:f>
              <c:strCache>
                <c:ptCount val="6"/>
                <c:pt idx="0">
                  <c:v>MM62</c:v>
                </c:pt>
                <c:pt idx="1">
                  <c:v>MM62 RH</c:v>
                </c:pt>
                <c:pt idx="2">
                  <c:v>MM84</c:v>
                </c:pt>
                <c:pt idx="3">
                  <c:v>MM84 RH</c:v>
                </c:pt>
                <c:pt idx="4">
                  <c:v>VU425</c:v>
                </c:pt>
                <c:pt idx="5">
                  <c:v>VU425 RH</c:v>
                </c:pt>
              </c:strCache>
              <c:extLst/>
            </c:strRef>
          </c:cat>
          <c:val>
            <c:numRef>
              <c:f>Feuil1!$B$13:$G$13</c:f>
              <c:numCache>
                <c:formatCode>General</c:formatCode>
                <c:ptCount val="6"/>
                <c:pt idx="0" formatCode="#,##0">
                  <c:v>1.2158186842653531</c:v>
                </c:pt>
                <c:pt idx="1">
                  <c:v>0.43284670878466353</c:v>
                </c:pt>
                <c:pt idx="2">
                  <c:v>0.99442060469364724</c:v>
                </c:pt>
                <c:pt idx="3">
                  <c:v>5.1901789613144914E-2</c:v>
                </c:pt>
                <c:pt idx="4">
                  <c:v>4.5375957765858033</c:v>
                </c:pt>
                <c:pt idx="5">
                  <c:v>0.12430257558670608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6-7713-4C19-8928-B672F00C3D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25"/>
        <c:axId val="1737312303"/>
        <c:axId val="1743055423"/>
        <c:extLst>
          <c:ext xmlns:c15="http://schemas.microsoft.com/office/drawing/2012/chart" uri="{02D57815-91ED-43cb-92C2-25804820EDAC}">
            <c15:filteredBarSeries>
              <c15:ser>
                <c:idx val="1"/>
                <c:order val="1"/>
                <c:tx>
                  <c:strRef>
                    <c:extLst>
                      <c:ext uri="{02D57815-91ED-43cb-92C2-25804820EDAC}">
                        <c15:formulaRef>
                          <c15:sqref>Feuil1!$A$1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2">
                      <a:alpha val="70000"/>
                    </a:schemeClr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ormulaRef>
                          <c15:sqref>Feuil1!$B$12:$G$12</c15:sqref>
                        </c15:formulaRef>
                      </c:ext>
                    </c:extLst>
                    <c:strCache>
                      <c:ptCount val="6"/>
                      <c:pt idx="0">
                        <c:v>MM62</c:v>
                      </c:pt>
                      <c:pt idx="1">
                        <c:v>MM62 RH</c:v>
                      </c:pt>
                      <c:pt idx="2">
                        <c:v>MM84</c:v>
                      </c:pt>
                      <c:pt idx="3">
                        <c:v>MM84 RH</c:v>
                      </c:pt>
                      <c:pt idx="4">
                        <c:v>VU425</c:v>
                      </c:pt>
                      <c:pt idx="5">
                        <c:v>VU425 RH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Feuil1!$B$14:$G$14</c15:sqref>
                        </c15:formulaRef>
                      </c:ext>
                    </c:extLst>
                    <c:numCache>
                      <c:formatCode>General</c:formatCode>
                      <c:ptCount val="6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7-7713-4C19-8928-B672F00C3D2C}"/>
                  </c:ext>
                </c:extLst>
              </c15:ser>
            </c15:filteredBarSeries>
          </c:ext>
        </c:extLst>
      </c:barChart>
      <c:catAx>
        <c:axId val="173731230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200"/>
                  <a:t>STRAINS</a:t>
                </a:r>
                <a:r>
                  <a:rPr lang="fr-CA" sz="1200" baseline="0"/>
                  <a:t> +/- Rnase hi (rh)</a:t>
                </a:r>
                <a:endParaRPr lang="fr-CA" sz="1200"/>
              </a:p>
            </c:rich>
          </c:tx>
          <c:layout>
            <c:manualLayout>
              <c:xMode val="edge"/>
              <c:yMode val="edge"/>
              <c:x val="0.30381288168814019"/>
              <c:y val="0.8815555141051667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cap="none" spc="20" normalizeH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43055423"/>
        <c:crosses val="autoZero"/>
        <c:auto val="1"/>
        <c:lblAlgn val="ctr"/>
        <c:lblOffset val="100"/>
        <c:noMultiLvlLbl val="0"/>
      </c:catAx>
      <c:valAx>
        <c:axId val="1743055423"/>
        <c:scaling>
          <c:orientation val="minMax"/>
          <c:max val="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200" baseline="0">
                    <a:solidFill>
                      <a:sysClr val="windowText" lastClr="000000"/>
                    </a:solidFill>
                  </a:rPr>
                  <a:t>% R-loops</a:t>
                </a:r>
                <a:endParaRPr lang="fr-CA" sz="120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#,##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spc="2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37312303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cap="none" spc="5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j-ea"/>
                <a:cs typeface="+mj-cs"/>
              </a:defRPr>
            </a:pPr>
            <a:r>
              <a:rPr lang="en-US" dirty="0" err="1"/>
              <a:t>ydcD</a:t>
            </a:r>
            <a:r>
              <a:rPr lang="en-US" baseline="0" dirty="0" err="1"/>
              <a:t>_duplicate</a:t>
            </a:r>
            <a:r>
              <a:rPr lang="en-US" baseline="0" dirty="0"/>
              <a:t> 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cap="none" spc="50" normalizeH="0" baseline="0">
              <a:solidFill>
                <a:schemeClr val="tx1">
                  <a:lumMod val="65000"/>
                  <a:lumOff val="35000"/>
                </a:schemeClr>
              </a:solidFill>
              <a:latin typeface="+mj-lt"/>
              <a:ea typeface="+mj-ea"/>
              <a:cs typeface="+mj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A$13</c:f>
              <c:strCache>
                <c:ptCount val="1"/>
                <c:pt idx="0">
                  <c:v>sDRIP</c:v>
                </c:pt>
              </c:strCache>
            </c:strRef>
          </c:tx>
          <c:spPr>
            <a:solidFill>
              <a:schemeClr val="accent1">
                <a:alpha val="70000"/>
              </a:schemeClr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4EB-4F5D-AE01-0602632DA1D6}"/>
              </c:ext>
            </c:extLst>
          </c:dPt>
          <c:dPt>
            <c:idx val="3"/>
            <c:invertIfNegative val="0"/>
            <c:bubble3D val="0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4EB-4F5D-AE01-0602632DA1D6}"/>
              </c:ext>
            </c:extLst>
          </c:dPt>
          <c:dPt>
            <c:idx val="5"/>
            <c:invertIfNegative val="0"/>
            <c:bubble3D val="0"/>
            <c:spPr>
              <a:solidFill>
                <a:srgbClr val="0070C0"/>
              </a:solidFill>
              <a:ln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4EB-4F5D-AE01-0602632DA1D6}"/>
              </c:ext>
            </c:extLst>
          </c:dPt>
          <c:cat>
            <c:strRef>
              <c:f>Feuil1!$B$12:$G$12</c:f>
              <c:strCache>
                <c:ptCount val="6"/>
                <c:pt idx="0">
                  <c:v>MM62</c:v>
                </c:pt>
                <c:pt idx="1">
                  <c:v>MM62 RH</c:v>
                </c:pt>
                <c:pt idx="2">
                  <c:v>MM84</c:v>
                </c:pt>
                <c:pt idx="3">
                  <c:v>MM84 RH</c:v>
                </c:pt>
                <c:pt idx="4">
                  <c:v>VU425</c:v>
                </c:pt>
                <c:pt idx="5">
                  <c:v>VU425 RH</c:v>
                </c:pt>
              </c:strCache>
              <c:extLst/>
            </c:strRef>
          </c:cat>
          <c:val>
            <c:numRef>
              <c:f>Feuil1!$B$13:$G$13</c:f>
              <c:numCache>
                <c:formatCode>General</c:formatCode>
                <c:ptCount val="6"/>
                <c:pt idx="0" formatCode="#,##0">
                  <c:v>1.3212725507017258</c:v>
                </c:pt>
                <c:pt idx="1">
                  <c:v>0.51474438579223381</c:v>
                </c:pt>
                <c:pt idx="2">
                  <c:v>0.90873282332519545</c:v>
                </c:pt>
                <c:pt idx="3">
                  <c:v>0.16862941195381698</c:v>
                </c:pt>
                <c:pt idx="4">
                  <c:v>4.3527528164806357</c:v>
                </c:pt>
                <c:pt idx="5">
                  <c:v>0.5953987487774600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6-D4EB-4F5D-AE01-0602632DA1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25"/>
        <c:axId val="1737312303"/>
        <c:axId val="1743055423"/>
        <c:extLst>
          <c:ext xmlns:c15="http://schemas.microsoft.com/office/drawing/2012/chart" uri="{02D57815-91ED-43cb-92C2-25804820EDAC}">
            <c15:filteredBarSeries>
              <c15:ser>
                <c:idx val="1"/>
                <c:order val="1"/>
                <c:tx>
                  <c:strRef>
                    <c:extLst>
                      <c:ext uri="{02D57815-91ED-43cb-92C2-25804820EDAC}">
                        <c15:formulaRef>
                          <c15:sqref>Feuil1!$A$1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solidFill>
                    <a:schemeClr val="accent2">
                      <a:alpha val="70000"/>
                    </a:schemeClr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ormulaRef>
                          <c15:sqref>Feuil1!$B$12:$G$12</c15:sqref>
                        </c15:formulaRef>
                      </c:ext>
                    </c:extLst>
                    <c:strCache>
                      <c:ptCount val="6"/>
                      <c:pt idx="0">
                        <c:v>MM62</c:v>
                      </c:pt>
                      <c:pt idx="1">
                        <c:v>MM62 RH</c:v>
                      </c:pt>
                      <c:pt idx="2">
                        <c:v>MM84</c:v>
                      </c:pt>
                      <c:pt idx="3">
                        <c:v>MM84 RH</c:v>
                      </c:pt>
                      <c:pt idx="4">
                        <c:v>VU425</c:v>
                      </c:pt>
                      <c:pt idx="5">
                        <c:v>VU425 RH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Feuil1!$B$14:$G$14</c15:sqref>
                        </c15:formulaRef>
                      </c:ext>
                    </c:extLst>
                    <c:numCache>
                      <c:formatCode>General</c:formatCode>
                      <c:ptCount val="6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7-D4EB-4F5D-AE01-0602632DA1D6}"/>
                  </c:ext>
                </c:extLst>
              </c15:ser>
            </c15:filteredBarSeries>
          </c:ext>
        </c:extLst>
      </c:barChart>
      <c:catAx>
        <c:axId val="173731230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200" dirty="0"/>
                  <a:t>STRAINS</a:t>
                </a:r>
                <a:r>
                  <a:rPr lang="fr-CA" sz="1200" baseline="0" dirty="0"/>
                  <a:t> +/- </a:t>
                </a:r>
                <a:r>
                  <a:rPr lang="fr-CA" sz="1200" baseline="0" dirty="0" err="1"/>
                  <a:t>Rnase</a:t>
                </a:r>
                <a:r>
                  <a:rPr lang="fr-CA" sz="1200" baseline="0" dirty="0"/>
                  <a:t> hi (</a:t>
                </a:r>
                <a:r>
                  <a:rPr lang="fr-CA" sz="1200" baseline="0" dirty="0" err="1"/>
                  <a:t>rh</a:t>
                </a:r>
                <a:r>
                  <a:rPr lang="fr-CA" sz="1200" baseline="0" dirty="0"/>
                  <a:t>)</a:t>
                </a:r>
                <a:endParaRPr lang="fr-CA" sz="12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cap="none" spc="20" normalizeH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43055423"/>
        <c:crosses val="autoZero"/>
        <c:auto val="1"/>
        <c:lblAlgn val="ctr"/>
        <c:lblOffset val="100"/>
        <c:noMultiLvlLbl val="0"/>
      </c:catAx>
      <c:valAx>
        <c:axId val="1743055423"/>
        <c:scaling>
          <c:orientation val="minMax"/>
          <c:max val="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cap="all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200">
                    <a:solidFill>
                      <a:schemeClr val="tx1"/>
                    </a:solidFill>
                  </a:rPr>
                  <a:t>% R-LOOP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cap="all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#,##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spc="2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37312303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587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 cap="none" spc="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50000"/>
          <a:lumOff val="50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>
            <a:alpha val="70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 baseline="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1600" b="0" i="0" kern="1200" cap="none" spc="5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587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 spc="20" baseline="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1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587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 cap="none" spc="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50000"/>
          <a:lumOff val="50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>
            <a:alpha val="70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 baseline="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1600" b="0" i="0" kern="1200" cap="none" spc="5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587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 spc="20" baseline="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431500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97859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98283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839911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934142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100139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036551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29035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3042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006043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169556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571979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76B25B02-C4B9-73D2-8F15-8E157050107E}"/>
              </a:ext>
            </a:extLst>
          </p:cNvPr>
          <p:cNvSpPr txBox="1"/>
          <p:nvPr/>
        </p:nvSpPr>
        <p:spPr>
          <a:xfrm>
            <a:off x="756623" y="447506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dirty="0"/>
              <a:t>S1 </a:t>
            </a:r>
            <a:r>
              <a:rPr lang="fr-CA" dirty="0" err="1"/>
              <a:t>Fig</a:t>
            </a:r>
            <a:endParaRPr lang="fr-CA" dirty="0"/>
          </a:p>
        </p:txBody>
      </p:sp>
      <p:graphicFrame>
        <p:nvGraphicFramePr>
          <p:cNvPr id="3" name="Graphique 2">
            <a:extLst>
              <a:ext uri="{FF2B5EF4-FFF2-40B4-BE49-F238E27FC236}">
                <a16:creationId xmlns:a16="http://schemas.microsoft.com/office/drawing/2014/main" id="{2004669A-E2A1-6C8D-CE86-51FFD2DF80EB}"/>
              </a:ext>
            </a:extLst>
          </p:cNvPr>
          <p:cNvGraphicFramePr>
            <a:graphicFrameLocks/>
          </p:cNvGraphicFramePr>
          <p:nvPr/>
        </p:nvGraphicFramePr>
        <p:xfrm>
          <a:off x="756622" y="1866901"/>
          <a:ext cx="3586777" cy="2724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6469E6DD-6FEC-9C07-1AD0-515443665DDC}"/>
              </a:ext>
            </a:extLst>
          </p:cNvPr>
          <p:cNvGraphicFramePr>
            <a:graphicFrameLocks/>
          </p:cNvGraphicFramePr>
          <p:nvPr/>
        </p:nvGraphicFramePr>
        <p:xfrm>
          <a:off x="4343399" y="1866901"/>
          <a:ext cx="3586776" cy="2724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84611357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28</TotalTime>
  <Words>28</Words>
  <Application>Microsoft Office PowerPoint</Application>
  <PresentationFormat>Affichage à l'écran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 Drolet</dc:creator>
  <cp:lastModifiedBy>Marc Drolet</cp:lastModifiedBy>
  <cp:revision>2</cp:revision>
  <dcterms:created xsi:type="dcterms:W3CDTF">2023-02-21T17:58:00Z</dcterms:created>
  <dcterms:modified xsi:type="dcterms:W3CDTF">2023-02-27T19:31:20Z</dcterms:modified>
</cp:coreProperties>
</file>